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04040"/>
    <a:srgbClr val="B0B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WB\Densitometria%20hif%20Nu_Cy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WB\Densitometria%20hif%20Nu_Cy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Foglio1!$B$37:$C$37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B0B0B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Foglio1!$B$38:$C$38</c:f>
              <c:numCache>
                <c:formatCode>General</c:formatCode>
                <c:ptCount val="2"/>
                <c:pt idx="0">
                  <c:v>0.43175303328658887</c:v>
                </c:pt>
                <c:pt idx="1">
                  <c:v>0.481232552335071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490424"/>
        <c:axId val="358493560"/>
      </c:barChart>
      <c:catAx>
        <c:axId val="358490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358493560"/>
        <c:crosses val="autoZero"/>
        <c:auto val="1"/>
        <c:lblAlgn val="ctr"/>
        <c:lblOffset val="100"/>
        <c:noMultiLvlLbl val="0"/>
      </c:catAx>
      <c:valAx>
        <c:axId val="3584935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358490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40404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Foglio1!$B$41:$C$41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B0B0B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Foglio1!$B$42:$C$42</c:f>
              <c:numCache>
                <c:formatCode>General</c:formatCode>
                <c:ptCount val="2"/>
                <c:pt idx="0">
                  <c:v>0.43308868272639378</c:v>
                </c:pt>
                <c:pt idx="1">
                  <c:v>0.420077225005959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492776"/>
        <c:axId val="358491992"/>
      </c:barChart>
      <c:catAx>
        <c:axId val="358492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358491992"/>
        <c:crosses val="autoZero"/>
        <c:auto val="1"/>
        <c:lblAlgn val="ctr"/>
        <c:lblOffset val="100"/>
        <c:noMultiLvlLbl val="0"/>
      </c:catAx>
      <c:valAx>
        <c:axId val="358491992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35849277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2383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0003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9527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4761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5645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1105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5730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4410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9366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2471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075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CE708-E3F7-4682-8BBA-8F24F2E6C7FB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EF34A-710F-4E0A-896F-B1A75868792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3236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4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openxmlformats.org/officeDocument/2006/relationships/chart" Target="../charts/char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uppo 60"/>
          <p:cNvGrpSpPr/>
          <p:nvPr/>
        </p:nvGrpSpPr>
        <p:grpSpPr>
          <a:xfrm>
            <a:off x="385846" y="1678956"/>
            <a:ext cx="11213427" cy="3875830"/>
            <a:chOff x="385846" y="1678956"/>
            <a:chExt cx="11213427" cy="3875830"/>
          </a:xfrm>
        </p:grpSpPr>
        <p:sp>
          <p:nvSpPr>
            <p:cNvPr id="27" name="Rettangolo 26"/>
            <p:cNvSpPr/>
            <p:nvPr/>
          </p:nvSpPr>
          <p:spPr>
            <a:xfrm>
              <a:off x="630731" y="4908455"/>
              <a:ext cx="10783449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5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ativ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ster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ts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corresponding 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nsitograms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that i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562 (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LAMA84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(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curcumin decreased nuclear levels of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F-1α. </a:t>
              </a:r>
              <a:r>
                <a:rPr lang="en-GB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nceau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 of nuclear extract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ed as loading control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Intensities of protein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nd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in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nceau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 the band used is indicated with arrow) were calculated from the peak area of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nsitogra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y using Image J software.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: control cells. 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0" name="Gruppo 59"/>
            <p:cNvGrpSpPr/>
            <p:nvPr/>
          </p:nvGrpSpPr>
          <p:grpSpPr>
            <a:xfrm>
              <a:off x="385846" y="1678956"/>
              <a:ext cx="11213427" cy="2942179"/>
              <a:chOff x="385846" y="1678956"/>
              <a:chExt cx="11213427" cy="2942179"/>
            </a:xfrm>
          </p:grpSpPr>
          <p:grpSp>
            <p:nvGrpSpPr>
              <p:cNvPr id="59" name="Gruppo 58"/>
              <p:cNvGrpSpPr/>
              <p:nvPr/>
            </p:nvGrpSpPr>
            <p:grpSpPr>
              <a:xfrm>
                <a:off x="385846" y="1976600"/>
                <a:ext cx="5830049" cy="2644535"/>
                <a:chOff x="58126" y="1837436"/>
                <a:chExt cx="5830049" cy="2644535"/>
              </a:xfrm>
            </p:grpSpPr>
            <p:sp>
              <p:nvSpPr>
                <p:cNvPr id="30" name="CasellaDiTesto 29"/>
                <p:cNvSpPr txBox="1"/>
                <p:nvPr/>
              </p:nvSpPr>
              <p:spPr>
                <a:xfrm>
                  <a:off x="135746" y="1895949"/>
                  <a:ext cx="32385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it-IT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1" name="Gruppo 30"/>
                <p:cNvGrpSpPr/>
                <p:nvPr/>
              </p:nvGrpSpPr>
              <p:grpSpPr>
                <a:xfrm>
                  <a:off x="3292875" y="1837436"/>
                  <a:ext cx="2595300" cy="2644535"/>
                  <a:chOff x="9076799" y="3265896"/>
                  <a:chExt cx="2595300" cy="2644535"/>
                </a:xfrm>
              </p:grpSpPr>
              <p:graphicFrame>
                <p:nvGraphicFramePr>
                  <p:cNvPr id="33" name="Grafico 32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411750105"/>
                      </p:ext>
                    </p:extLst>
                  </p:nvPr>
                </p:nvGraphicFramePr>
                <p:xfrm>
                  <a:off x="9076799" y="3324409"/>
                  <a:ext cx="1727677" cy="2553973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grpSp>
                <p:nvGrpSpPr>
                  <p:cNvPr id="34" name="Gruppo 33"/>
                  <p:cNvGrpSpPr/>
                  <p:nvPr/>
                </p:nvGrpSpPr>
                <p:grpSpPr>
                  <a:xfrm>
                    <a:off x="10453640" y="3265896"/>
                    <a:ext cx="1218459" cy="537689"/>
                    <a:chOff x="6463386" y="563085"/>
                    <a:chExt cx="1346428" cy="539404"/>
                  </a:xfrm>
                </p:grpSpPr>
                <p:sp>
                  <p:nvSpPr>
                    <p:cNvPr id="38" name="Rettangolo 37"/>
                    <p:cNvSpPr/>
                    <p:nvPr/>
                  </p:nvSpPr>
                  <p:spPr>
                    <a:xfrm>
                      <a:off x="6463386" y="658876"/>
                      <a:ext cx="78512" cy="77729"/>
                    </a:xfrm>
                    <a:prstGeom prst="rect">
                      <a:avLst/>
                    </a:prstGeom>
                    <a:solidFill>
                      <a:srgbClr val="5F5F5F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it-IT"/>
                    </a:p>
                  </p:txBody>
                </p:sp>
                <p:sp>
                  <p:nvSpPr>
                    <p:cNvPr id="39" name="Rettangolo 38"/>
                    <p:cNvSpPr/>
                    <p:nvPr/>
                  </p:nvSpPr>
                  <p:spPr>
                    <a:xfrm>
                      <a:off x="6469518" y="925936"/>
                      <a:ext cx="78512" cy="77729"/>
                    </a:xfrm>
                    <a:prstGeom prst="rect">
                      <a:avLst/>
                    </a:prstGeom>
                    <a:solidFill>
                      <a:srgbClr val="D0CECE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it-IT"/>
                    </a:p>
                  </p:txBody>
                </p:sp>
                <p:sp>
                  <p:nvSpPr>
                    <p:cNvPr id="40" name="CasellaDiTesto 39"/>
                    <p:cNvSpPr txBox="1"/>
                    <p:nvPr/>
                  </p:nvSpPr>
                  <p:spPr>
                    <a:xfrm>
                      <a:off x="6515210" y="563085"/>
                      <a:ext cx="430353" cy="2741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it-IT" sz="105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endParaRPr lang="it-IT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1" name="CasellaDiTesto 40"/>
                    <p:cNvSpPr txBox="1"/>
                    <p:nvPr/>
                  </p:nvSpPr>
                  <p:spPr>
                    <a:xfrm>
                      <a:off x="6526447" y="828371"/>
                      <a:ext cx="1283367" cy="2741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it-IT" sz="105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rcumin</a:t>
                      </a:r>
                      <a:r>
                        <a:rPr lang="it-IT" sz="105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0 µM</a:t>
                      </a:r>
                      <a:endParaRPr lang="it-IT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5" name="Rettangolo 34"/>
                  <p:cNvSpPr/>
                  <p:nvPr/>
                </p:nvSpPr>
                <p:spPr>
                  <a:xfrm>
                    <a:off x="9407089" y="5738120"/>
                    <a:ext cx="1218043" cy="17231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6" name="CasellaDiTesto 35"/>
                  <p:cNvSpPr txBox="1"/>
                  <p:nvPr/>
                </p:nvSpPr>
                <p:spPr>
                  <a:xfrm>
                    <a:off x="10043632" y="5614424"/>
                    <a:ext cx="651631" cy="245438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F-1</a:t>
                    </a:r>
                    <a:r>
                      <a:rPr lang="el-GR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2</a:t>
                    </a:r>
                    <a:endParaRPr lang="it-IT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CasellaDiTesto 36"/>
                  <p:cNvSpPr txBox="1"/>
                  <p:nvPr/>
                </p:nvSpPr>
                <p:spPr>
                  <a:xfrm>
                    <a:off x="9410376" y="5615401"/>
                    <a:ext cx="651631" cy="245438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F-1</a:t>
                    </a:r>
                    <a:r>
                      <a:rPr lang="el-GR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</a:t>
                    </a:r>
                    <a:endParaRPr lang="it-IT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8" name="Gruppo 57"/>
                <p:cNvGrpSpPr/>
                <p:nvPr/>
              </p:nvGrpSpPr>
              <p:grpSpPr>
                <a:xfrm>
                  <a:off x="58126" y="2241972"/>
                  <a:ext cx="3231090" cy="2042842"/>
                  <a:chOff x="58126" y="2241972"/>
                  <a:chExt cx="3231090" cy="2042842"/>
                </a:xfrm>
              </p:grpSpPr>
              <p:grpSp>
                <p:nvGrpSpPr>
                  <p:cNvPr id="50" name="Gruppo 49"/>
                  <p:cNvGrpSpPr/>
                  <p:nvPr/>
                </p:nvGrpSpPr>
                <p:grpSpPr>
                  <a:xfrm>
                    <a:off x="1285015" y="2241972"/>
                    <a:ext cx="2004201" cy="1798258"/>
                    <a:chOff x="1309269" y="2624781"/>
                    <a:chExt cx="2004201" cy="1798258"/>
                  </a:xfrm>
                </p:grpSpPr>
                <p:grpSp>
                  <p:nvGrpSpPr>
                    <p:cNvPr id="29" name="Gruppo 28"/>
                    <p:cNvGrpSpPr/>
                    <p:nvPr/>
                  </p:nvGrpSpPr>
                  <p:grpSpPr>
                    <a:xfrm>
                      <a:off x="1309269" y="2624781"/>
                      <a:ext cx="2004201" cy="1685494"/>
                      <a:chOff x="4226981" y="1167916"/>
                      <a:chExt cx="2004201" cy="1685494"/>
                    </a:xfrm>
                  </p:grpSpPr>
                  <p:pic>
                    <p:nvPicPr>
                      <p:cNvPr id="42" name="Immagine 41"/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26981" y="1167916"/>
                        <a:ext cx="824594" cy="57849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  <p:sp>
                    <p:nvSpPr>
                      <p:cNvPr id="43" name="CasellaDiTesto 42"/>
                      <p:cNvSpPr txBox="1"/>
                      <p:nvPr/>
                    </p:nvSpPr>
                    <p:spPr>
                      <a:xfrm>
                        <a:off x="5172854" y="1171148"/>
                        <a:ext cx="755335" cy="2539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it-IT" sz="105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IF-1</a:t>
                        </a:r>
                        <a:r>
                          <a:rPr lang="el-GR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_1</a:t>
                        </a:r>
                        <a:endParaRPr lang="it-IT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4" name="CasellaDiTesto 43"/>
                      <p:cNvSpPr txBox="1"/>
                      <p:nvPr/>
                    </p:nvSpPr>
                    <p:spPr>
                      <a:xfrm>
                        <a:off x="5018991" y="1759873"/>
                        <a:ext cx="1212191" cy="41549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 </a:t>
                        </a:r>
                        <a:r>
                          <a:rPr lang="it-IT" sz="1050" b="1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oading</a:t>
                        </a:r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</a:p>
                      <a:p>
                        <a:pPr algn="ctr"/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Ponceau S)</a:t>
                        </a:r>
                        <a:endParaRPr lang="it-IT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45" name="Connettore 2 44"/>
                      <p:cNvCxnSpPr/>
                      <p:nvPr/>
                    </p:nvCxnSpPr>
                    <p:spPr>
                      <a:xfrm flipH="1">
                        <a:off x="5090536" y="1287635"/>
                        <a:ext cx="101546" cy="5979"/>
                      </a:xfrm>
                      <a:prstGeom prst="straightConnector1">
                        <a:avLst/>
                      </a:prstGeom>
                      <a:ln w="381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" name="Connettore 2 45"/>
                      <p:cNvCxnSpPr/>
                      <p:nvPr/>
                    </p:nvCxnSpPr>
                    <p:spPr>
                      <a:xfrm flipH="1">
                        <a:off x="5083618" y="2847431"/>
                        <a:ext cx="101546" cy="5979"/>
                      </a:xfrm>
                      <a:prstGeom prst="straightConnector1">
                        <a:avLst/>
                      </a:prstGeom>
                      <a:ln w="381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7" name="CasellaDiTesto 46"/>
                      <p:cNvSpPr txBox="1"/>
                      <p:nvPr/>
                    </p:nvSpPr>
                    <p:spPr>
                      <a:xfrm>
                        <a:off x="5172854" y="1425064"/>
                        <a:ext cx="755335" cy="2539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it-IT" sz="105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IF-1</a:t>
                        </a:r>
                        <a:r>
                          <a:rPr lang="el-GR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_2</a:t>
                        </a:r>
                        <a:endParaRPr lang="it-IT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48" name="Connettore 2 47"/>
                      <p:cNvCxnSpPr/>
                      <p:nvPr/>
                    </p:nvCxnSpPr>
                    <p:spPr>
                      <a:xfrm flipH="1">
                        <a:off x="5090536" y="1541551"/>
                        <a:ext cx="101546" cy="5979"/>
                      </a:xfrm>
                      <a:prstGeom prst="straightConnector1">
                        <a:avLst/>
                      </a:prstGeom>
                      <a:ln w="381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pic>
                  <p:nvPicPr>
                    <p:cNvPr id="49" name="Immagine 48"/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1309269" y="3262809"/>
                      <a:ext cx="823713" cy="116023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  <p:sp>
                <p:nvSpPr>
                  <p:cNvPr id="51" name="CasellaDiTesto 50"/>
                  <p:cNvSpPr txBox="1"/>
                  <p:nvPr/>
                </p:nvSpPr>
                <p:spPr>
                  <a:xfrm>
                    <a:off x="1334414" y="4003115"/>
                    <a:ext cx="23596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CasellaDiTesto 51"/>
                  <p:cNvSpPr txBox="1"/>
                  <p:nvPr/>
                </p:nvSpPr>
                <p:spPr>
                  <a:xfrm>
                    <a:off x="1778328" y="4007815"/>
                    <a:ext cx="274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CasellaDiTesto 52"/>
                  <p:cNvSpPr txBox="1"/>
                  <p:nvPr/>
                </p:nvSpPr>
                <p:spPr>
                  <a:xfrm>
                    <a:off x="58126" y="4022018"/>
                    <a:ext cx="122661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7" name="Gruppo 56"/>
              <p:cNvGrpSpPr/>
              <p:nvPr/>
            </p:nvGrpSpPr>
            <p:grpSpPr>
              <a:xfrm>
                <a:off x="6407853" y="1678956"/>
                <a:ext cx="5191420" cy="2915736"/>
                <a:chOff x="5973325" y="1467951"/>
                <a:chExt cx="5191420" cy="2915736"/>
              </a:xfrm>
            </p:grpSpPr>
            <p:sp>
              <p:nvSpPr>
                <p:cNvPr id="4" name="CasellaDiTesto 3"/>
                <p:cNvSpPr txBox="1"/>
                <p:nvPr/>
              </p:nvSpPr>
              <p:spPr>
                <a:xfrm>
                  <a:off x="6027712" y="1721867"/>
                  <a:ext cx="3044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it-IT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5" name="Gruppo 4"/>
                <p:cNvGrpSpPr/>
                <p:nvPr/>
              </p:nvGrpSpPr>
              <p:grpSpPr>
                <a:xfrm>
                  <a:off x="9136416" y="1467951"/>
                  <a:ext cx="2028329" cy="2915736"/>
                  <a:chOff x="7599445" y="2311532"/>
                  <a:chExt cx="2028329" cy="2915736"/>
                </a:xfrm>
              </p:grpSpPr>
              <p:grpSp>
                <p:nvGrpSpPr>
                  <p:cNvPr id="6" name="Gruppo 5"/>
                  <p:cNvGrpSpPr/>
                  <p:nvPr/>
                </p:nvGrpSpPr>
                <p:grpSpPr>
                  <a:xfrm>
                    <a:off x="7599445" y="2484068"/>
                    <a:ext cx="1843237" cy="2743200"/>
                    <a:chOff x="7067606" y="3399883"/>
                    <a:chExt cx="1843237" cy="2743200"/>
                  </a:xfrm>
                </p:grpSpPr>
                <p:grpSp>
                  <p:nvGrpSpPr>
                    <p:cNvPr id="12" name="Gruppo 11"/>
                    <p:cNvGrpSpPr/>
                    <p:nvPr/>
                  </p:nvGrpSpPr>
                  <p:grpSpPr>
                    <a:xfrm>
                      <a:off x="7067606" y="3399883"/>
                      <a:ext cx="1843237" cy="2743200"/>
                      <a:chOff x="6591062" y="3224518"/>
                      <a:chExt cx="1843237" cy="2743200"/>
                    </a:xfrm>
                  </p:grpSpPr>
                  <p:graphicFrame>
                    <p:nvGraphicFramePr>
                      <p:cNvPr id="15" name="Grafico 14"/>
                      <p:cNvGraphicFramePr>
                        <a:graphicFrameLocks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2576055212"/>
                          </p:ext>
                        </p:extLst>
                      </p:nvPr>
                    </p:nvGraphicFramePr>
                    <p:xfrm>
                      <a:off x="6591062" y="3224518"/>
                      <a:ext cx="1843237" cy="274320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  <p:sp>
                    <p:nvSpPr>
                      <p:cNvPr id="16" name="Rettangolo 15"/>
                      <p:cNvSpPr/>
                      <p:nvPr/>
                    </p:nvSpPr>
                    <p:spPr>
                      <a:xfrm>
                        <a:off x="7106212" y="5722290"/>
                        <a:ext cx="996388" cy="23066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it-IT"/>
                      </a:p>
                    </p:txBody>
                  </p:sp>
                </p:grpSp>
                <p:sp>
                  <p:nvSpPr>
                    <p:cNvPr id="13" name="CasellaDiTesto 12"/>
                    <p:cNvSpPr txBox="1"/>
                    <p:nvPr/>
                  </p:nvSpPr>
                  <p:spPr>
                    <a:xfrm>
                      <a:off x="8115885" y="5843635"/>
                      <a:ext cx="651631" cy="24543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F-1</a:t>
                      </a:r>
                      <a:r>
                        <a:rPr lang="el-G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2</a:t>
                      </a:r>
                      <a:endPara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" name="CasellaDiTesto 13"/>
                    <p:cNvSpPr txBox="1"/>
                    <p:nvPr/>
                  </p:nvSpPr>
                  <p:spPr>
                    <a:xfrm>
                      <a:off x="7404304" y="5842447"/>
                      <a:ext cx="651631" cy="24543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F-1</a:t>
                      </a:r>
                      <a:r>
                        <a:rPr lang="el-G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1</a:t>
                      </a:r>
                      <a:endPara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7" name="Gruppo 6"/>
                  <p:cNvGrpSpPr/>
                  <p:nvPr/>
                </p:nvGrpSpPr>
                <p:grpSpPr>
                  <a:xfrm>
                    <a:off x="8398643" y="2311532"/>
                    <a:ext cx="1229131" cy="461375"/>
                    <a:chOff x="8398643" y="2311532"/>
                    <a:chExt cx="1229131" cy="461375"/>
                  </a:xfrm>
                </p:grpSpPr>
                <p:sp>
                  <p:nvSpPr>
                    <p:cNvPr id="8" name="Rettangolo 7"/>
                    <p:cNvSpPr/>
                    <p:nvPr/>
                  </p:nvSpPr>
                  <p:spPr>
                    <a:xfrm>
                      <a:off x="8398643" y="2400263"/>
                      <a:ext cx="72000" cy="72000"/>
                    </a:xfrm>
                    <a:prstGeom prst="rect">
                      <a:avLst/>
                    </a:prstGeom>
                    <a:solidFill>
                      <a:srgbClr val="5F5F5F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it-IT"/>
                    </a:p>
                  </p:txBody>
                </p:sp>
                <p:sp>
                  <p:nvSpPr>
                    <p:cNvPr id="9" name="CasellaDiTesto 8"/>
                    <p:cNvSpPr txBox="1"/>
                    <p:nvPr/>
                  </p:nvSpPr>
                  <p:spPr>
                    <a:xfrm>
                      <a:off x="8446168" y="2311532"/>
                      <a:ext cx="394660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it-IT" sz="105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endParaRPr lang="it-IT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" name="Rettangolo 9"/>
                    <p:cNvSpPr/>
                    <p:nvPr/>
                  </p:nvSpPr>
                  <p:spPr>
                    <a:xfrm>
                      <a:off x="8398643" y="2609364"/>
                      <a:ext cx="72000" cy="72000"/>
                    </a:xfrm>
                    <a:prstGeom prst="rect">
                      <a:avLst/>
                    </a:prstGeom>
                    <a:solidFill>
                      <a:srgbClr val="D0CECE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it-IT"/>
                    </a:p>
                  </p:txBody>
                </p:sp>
                <p:sp>
                  <p:nvSpPr>
                    <p:cNvPr id="11" name="CasellaDiTesto 10"/>
                    <p:cNvSpPr txBox="1"/>
                    <p:nvPr/>
                  </p:nvSpPr>
                  <p:spPr>
                    <a:xfrm>
                      <a:off x="8450849" y="2518991"/>
                      <a:ext cx="1176925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it-IT" sz="105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rcumin</a:t>
                      </a:r>
                      <a:r>
                        <a:rPr lang="it-IT" sz="105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0 µM</a:t>
                      </a:r>
                      <a:endParaRPr lang="it-IT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2" name="Gruppo 31"/>
                <p:cNvGrpSpPr/>
                <p:nvPr/>
              </p:nvGrpSpPr>
              <p:grpSpPr>
                <a:xfrm>
                  <a:off x="5973325" y="2394630"/>
                  <a:ext cx="3268463" cy="1831738"/>
                  <a:chOff x="5973325" y="2394630"/>
                  <a:chExt cx="3268463" cy="1831738"/>
                </a:xfrm>
              </p:grpSpPr>
              <p:grpSp>
                <p:nvGrpSpPr>
                  <p:cNvPr id="3" name="Gruppo 2"/>
                  <p:cNvGrpSpPr/>
                  <p:nvPr/>
                </p:nvGrpSpPr>
                <p:grpSpPr>
                  <a:xfrm>
                    <a:off x="7080525" y="2394630"/>
                    <a:ext cx="2161263" cy="1553228"/>
                    <a:chOff x="5011715" y="3823826"/>
                    <a:chExt cx="2161263" cy="1553228"/>
                  </a:xfrm>
                </p:grpSpPr>
                <p:pic>
                  <p:nvPicPr>
                    <p:cNvPr id="17" name="Immagine 16"/>
                    <p:cNvPicPr>
                      <a:picLocks noChangeAspect="1"/>
                    </p:cNvPicPr>
                    <p:nvPr/>
                  </p:nvPicPr>
                  <p:blipFill rotWithShape="1"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4664" t="20241" r="48707" b="70118"/>
                    <a:stretch/>
                  </p:blipFill>
                  <p:spPr>
                    <a:xfrm>
                      <a:off x="5011715" y="3823826"/>
                      <a:ext cx="974472" cy="421947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18" name="Immagine 17"/>
                    <p:cNvPicPr>
                      <a:picLocks noChangeAspect="1"/>
                    </p:cNvPicPr>
                    <p:nvPr/>
                  </p:nvPicPr>
                  <p:blipFill rotWithShape="1"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6739" t="17911" r="46631" b="57641"/>
                    <a:stretch/>
                  </p:blipFill>
                  <p:spPr>
                    <a:xfrm>
                      <a:off x="5011715" y="4307044"/>
                      <a:ext cx="974472" cy="107001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9" name="CasellaDiTesto 18"/>
                    <p:cNvSpPr txBox="1"/>
                    <p:nvPr/>
                  </p:nvSpPr>
                  <p:spPr>
                    <a:xfrm>
                      <a:off x="5960787" y="4267609"/>
                      <a:ext cx="1212191" cy="41549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it-IT" sz="10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</a:t>
                      </a:r>
                      <a:r>
                        <a:rPr lang="it-IT" sz="105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ading</a:t>
                      </a:r>
                      <a:r>
                        <a:rPr lang="it-IT" sz="10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it-IT" sz="105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onceau S)</a:t>
                      </a:r>
                      <a:endParaRPr lang="it-IT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20" name="Gruppo 19"/>
                    <p:cNvGrpSpPr/>
                    <p:nvPr/>
                  </p:nvGrpSpPr>
                  <p:grpSpPr>
                    <a:xfrm>
                      <a:off x="6032332" y="3836730"/>
                      <a:ext cx="837653" cy="253916"/>
                      <a:chOff x="6032332" y="3798630"/>
                      <a:chExt cx="837653" cy="253916"/>
                    </a:xfrm>
                  </p:grpSpPr>
                  <p:sp>
                    <p:nvSpPr>
                      <p:cNvPr id="25" name="CasellaDiTesto 24"/>
                      <p:cNvSpPr txBox="1"/>
                      <p:nvPr/>
                    </p:nvSpPr>
                    <p:spPr>
                      <a:xfrm>
                        <a:off x="6114650" y="3798630"/>
                        <a:ext cx="755335" cy="2539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it-IT" sz="105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IF-1</a:t>
                        </a:r>
                        <a:r>
                          <a:rPr lang="el-GR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_1</a:t>
                        </a:r>
                        <a:endParaRPr lang="it-IT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26" name="Connettore 2 25"/>
                      <p:cNvCxnSpPr/>
                      <p:nvPr/>
                    </p:nvCxnSpPr>
                    <p:spPr>
                      <a:xfrm flipH="1">
                        <a:off x="6032332" y="3915117"/>
                        <a:ext cx="101546" cy="5979"/>
                      </a:xfrm>
                      <a:prstGeom prst="straightConnector1">
                        <a:avLst/>
                      </a:prstGeom>
                      <a:ln w="381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21" name="Connettore 2 20"/>
                    <p:cNvCxnSpPr/>
                    <p:nvPr/>
                  </p:nvCxnSpPr>
                  <p:spPr>
                    <a:xfrm flipH="1">
                      <a:off x="6025414" y="4876205"/>
                      <a:ext cx="101546" cy="5979"/>
                    </a:xfrm>
                    <a:prstGeom prst="straightConnector1">
                      <a:avLst/>
                    </a:prstGeom>
                    <a:ln w="381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2" name="Gruppo 21"/>
                    <p:cNvGrpSpPr/>
                    <p:nvPr/>
                  </p:nvGrpSpPr>
                  <p:grpSpPr>
                    <a:xfrm>
                      <a:off x="6032332" y="3992674"/>
                      <a:ext cx="837653" cy="253916"/>
                      <a:chOff x="6032332" y="3992674"/>
                      <a:chExt cx="837653" cy="253916"/>
                    </a:xfrm>
                  </p:grpSpPr>
                  <p:sp>
                    <p:nvSpPr>
                      <p:cNvPr id="23" name="CasellaDiTesto 22"/>
                      <p:cNvSpPr txBox="1"/>
                      <p:nvPr/>
                    </p:nvSpPr>
                    <p:spPr>
                      <a:xfrm>
                        <a:off x="6114650" y="3992674"/>
                        <a:ext cx="755335" cy="2539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it-IT" sz="105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IF-1</a:t>
                        </a:r>
                        <a:r>
                          <a:rPr lang="el-GR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it-IT" sz="105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_2</a:t>
                        </a:r>
                        <a:endParaRPr lang="it-IT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24" name="Connettore 2 23"/>
                      <p:cNvCxnSpPr/>
                      <p:nvPr/>
                    </p:nvCxnSpPr>
                    <p:spPr>
                      <a:xfrm flipH="1">
                        <a:off x="6032332" y="4109161"/>
                        <a:ext cx="101546" cy="5979"/>
                      </a:xfrm>
                      <a:prstGeom prst="straightConnector1">
                        <a:avLst/>
                      </a:prstGeom>
                      <a:ln w="381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54" name="CasellaDiTesto 53"/>
                  <p:cNvSpPr txBox="1"/>
                  <p:nvPr/>
                </p:nvSpPr>
                <p:spPr>
                  <a:xfrm>
                    <a:off x="7249613" y="3944669"/>
                    <a:ext cx="23596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" name="CasellaDiTesto 54"/>
                  <p:cNvSpPr txBox="1"/>
                  <p:nvPr/>
                </p:nvSpPr>
                <p:spPr>
                  <a:xfrm>
                    <a:off x="7693527" y="3949369"/>
                    <a:ext cx="274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" name="CasellaDiTesto 55"/>
                  <p:cNvSpPr txBox="1"/>
                  <p:nvPr/>
                </p:nvSpPr>
                <p:spPr>
                  <a:xfrm>
                    <a:off x="5973325" y="3963572"/>
                    <a:ext cx="122661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22751606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131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9</cp:revision>
  <cp:lastPrinted>2018-06-22T11:06:58Z</cp:lastPrinted>
  <dcterms:created xsi:type="dcterms:W3CDTF">2018-06-22T09:05:49Z</dcterms:created>
  <dcterms:modified xsi:type="dcterms:W3CDTF">2018-07-11T09:59:20Z</dcterms:modified>
</cp:coreProperties>
</file>